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94" r:id="rId2"/>
  </p:sldIdLst>
  <p:sldSz cx="36036250" cy="5039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>
      <p:cViewPr varScale="1">
        <p:scale>
          <a:sx n="16" d="100"/>
          <a:sy n="16" d="100"/>
        </p:scale>
        <p:origin x="3648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EA346F-67DC-4D70-A257-76E567803AA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87EA93-14CA-4B80-8A2B-8DA1502EFC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6246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1pPr>
    <a:lvl2pPr marL="1385865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2pPr>
    <a:lvl3pPr marL="2771729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3pPr>
    <a:lvl4pPr marL="4157594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4pPr>
    <a:lvl5pPr marL="5543459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5pPr>
    <a:lvl6pPr marL="6929323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6pPr>
    <a:lvl7pPr marL="8315188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7pPr>
    <a:lvl8pPr marL="9701052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8pPr>
    <a:lvl9pPr marL="11086917" algn="l" defTabSz="2771729" rtl="0" eaLnBrk="1" latinLnBrk="0" hangingPunct="1">
      <a:defRPr kumimoji="1" sz="36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2719" y="8248329"/>
            <a:ext cx="30630813" cy="17546649"/>
          </a:xfrm>
        </p:spPr>
        <p:txBody>
          <a:bodyPr anchor="b"/>
          <a:lstStyle>
            <a:lvl1pPr algn="ctr">
              <a:defRPr sz="2364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04531" y="26471644"/>
            <a:ext cx="27027188" cy="12168318"/>
          </a:xfrm>
        </p:spPr>
        <p:txBody>
          <a:bodyPr/>
          <a:lstStyle>
            <a:lvl1pPr marL="0" indent="0" algn="ctr">
              <a:buNone/>
              <a:defRPr sz="9458"/>
            </a:lvl1pPr>
            <a:lvl2pPr marL="1801825" indent="0" algn="ctr">
              <a:buNone/>
              <a:defRPr sz="7882"/>
            </a:lvl2pPr>
            <a:lvl3pPr marL="3603650" indent="0" algn="ctr">
              <a:buNone/>
              <a:defRPr sz="7094"/>
            </a:lvl3pPr>
            <a:lvl4pPr marL="5405476" indent="0" algn="ctr">
              <a:buNone/>
              <a:defRPr sz="6306"/>
            </a:lvl4pPr>
            <a:lvl5pPr marL="7207301" indent="0" algn="ctr">
              <a:buNone/>
              <a:defRPr sz="6306"/>
            </a:lvl5pPr>
            <a:lvl6pPr marL="9009126" indent="0" algn="ctr">
              <a:buNone/>
              <a:defRPr sz="6306"/>
            </a:lvl6pPr>
            <a:lvl7pPr marL="10810951" indent="0" algn="ctr">
              <a:buNone/>
              <a:defRPr sz="6306"/>
            </a:lvl7pPr>
            <a:lvl8pPr marL="12612776" indent="0" algn="ctr">
              <a:buNone/>
              <a:defRPr sz="6306"/>
            </a:lvl8pPr>
            <a:lvl9pPr marL="14414602" indent="0" algn="ctr">
              <a:buNone/>
              <a:defRPr sz="630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17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0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88444" y="2683331"/>
            <a:ext cx="7770316" cy="4271162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7494" y="2683331"/>
            <a:ext cx="22860496" cy="4271162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6572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970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8725" y="12565002"/>
            <a:ext cx="31081266" cy="20964976"/>
          </a:xfrm>
        </p:spPr>
        <p:txBody>
          <a:bodyPr anchor="b"/>
          <a:lstStyle>
            <a:lvl1pPr>
              <a:defRPr sz="2364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8725" y="33728315"/>
            <a:ext cx="31081266" cy="11024985"/>
          </a:xfrm>
        </p:spPr>
        <p:txBody>
          <a:bodyPr/>
          <a:lstStyle>
            <a:lvl1pPr marL="0" indent="0">
              <a:buNone/>
              <a:defRPr sz="9458">
                <a:solidFill>
                  <a:schemeClr val="tx1"/>
                </a:solidFill>
              </a:defRPr>
            </a:lvl1pPr>
            <a:lvl2pPr marL="1801825" indent="0">
              <a:buNone/>
              <a:defRPr sz="7882">
                <a:solidFill>
                  <a:schemeClr val="tx1">
                    <a:tint val="75000"/>
                  </a:schemeClr>
                </a:solidFill>
              </a:defRPr>
            </a:lvl2pPr>
            <a:lvl3pPr marL="3603650" indent="0">
              <a:buNone/>
              <a:defRPr sz="7094">
                <a:solidFill>
                  <a:schemeClr val="tx1">
                    <a:tint val="75000"/>
                  </a:schemeClr>
                </a:solidFill>
              </a:defRPr>
            </a:lvl3pPr>
            <a:lvl4pPr marL="5405476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4pPr>
            <a:lvl5pPr marL="7207301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5pPr>
            <a:lvl6pPr marL="9009126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6pPr>
            <a:lvl7pPr marL="10810951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7pPr>
            <a:lvl8pPr marL="12612776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8pPr>
            <a:lvl9pPr marL="14414602" indent="0">
              <a:buNone/>
              <a:defRPr sz="630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247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7492" y="13416653"/>
            <a:ext cx="15315406" cy="319783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43352" y="13416653"/>
            <a:ext cx="15315406" cy="319783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4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2186" y="2683342"/>
            <a:ext cx="31081266" cy="974166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2190" y="12354992"/>
            <a:ext cx="15245020" cy="6054990"/>
          </a:xfrm>
        </p:spPr>
        <p:txBody>
          <a:bodyPr anchor="b"/>
          <a:lstStyle>
            <a:lvl1pPr marL="0" indent="0">
              <a:buNone/>
              <a:defRPr sz="9458" b="1"/>
            </a:lvl1pPr>
            <a:lvl2pPr marL="1801825" indent="0">
              <a:buNone/>
              <a:defRPr sz="7882" b="1"/>
            </a:lvl2pPr>
            <a:lvl3pPr marL="3603650" indent="0">
              <a:buNone/>
              <a:defRPr sz="7094" b="1"/>
            </a:lvl3pPr>
            <a:lvl4pPr marL="5405476" indent="0">
              <a:buNone/>
              <a:defRPr sz="6306" b="1"/>
            </a:lvl4pPr>
            <a:lvl5pPr marL="7207301" indent="0">
              <a:buNone/>
              <a:defRPr sz="6306" b="1"/>
            </a:lvl5pPr>
            <a:lvl6pPr marL="9009126" indent="0">
              <a:buNone/>
              <a:defRPr sz="6306" b="1"/>
            </a:lvl6pPr>
            <a:lvl7pPr marL="10810951" indent="0">
              <a:buNone/>
              <a:defRPr sz="6306" b="1"/>
            </a:lvl7pPr>
            <a:lvl8pPr marL="12612776" indent="0">
              <a:buNone/>
              <a:defRPr sz="6306" b="1"/>
            </a:lvl8pPr>
            <a:lvl9pPr marL="14414602" indent="0">
              <a:buNone/>
              <a:defRPr sz="630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82190" y="18409982"/>
            <a:ext cx="15245020" cy="2707831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43354" y="12354992"/>
            <a:ext cx="15320100" cy="6054990"/>
          </a:xfrm>
        </p:spPr>
        <p:txBody>
          <a:bodyPr anchor="b"/>
          <a:lstStyle>
            <a:lvl1pPr marL="0" indent="0">
              <a:buNone/>
              <a:defRPr sz="9458" b="1"/>
            </a:lvl1pPr>
            <a:lvl2pPr marL="1801825" indent="0">
              <a:buNone/>
              <a:defRPr sz="7882" b="1"/>
            </a:lvl2pPr>
            <a:lvl3pPr marL="3603650" indent="0">
              <a:buNone/>
              <a:defRPr sz="7094" b="1"/>
            </a:lvl3pPr>
            <a:lvl4pPr marL="5405476" indent="0">
              <a:buNone/>
              <a:defRPr sz="6306" b="1"/>
            </a:lvl4pPr>
            <a:lvl5pPr marL="7207301" indent="0">
              <a:buNone/>
              <a:defRPr sz="6306" b="1"/>
            </a:lvl5pPr>
            <a:lvl6pPr marL="9009126" indent="0">
              <a:buNone/>
              <a:defRPr sz="6306" b="1"/>
            </a:lvl6pPr>
            <a:lvl7pPr marL="10810951" indent="0">
              <a:buNone/>
              <a:defRPr sz="6306" b="1"/>
            </a:lvl7pPr>
            <a:lvl8pPr marL="12612776" indent="0">
              <a:buNone/>
              <a:defRPr sz="6306" b="1"/>
            </a:lvl8pPr>
            <a:lvl9pPr marL="14414602" indent="0">
              <a:buNone/>
              <a:defRPr sz="630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43354" y="18409982"/>
            <a:ext cx="15320100" cy="2707831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574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857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482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2186" y="3359997"/>
            <a:ext cx="11622629" cy="11759988"/>
          </a:xfrm>
        </p:spPr>
        <p:txBody>
          <a:bodyPr anchor="b"/>
          <a:lstStyle>
            <a:lvl1pPr>
              <a:defRPr sz="126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20100" y="7256671"/>
            <a:ext cx="18243352" cy="35816631"/>
          </a:xfrm>
        </p:spPr>
        <p:txBody>
          <a:bodyPr/>
          <a:lstStyle>
            <a:lvl1pPr>
              <a:defRPr sz="12611"/>
            </a:lvl1pPr>
            <a:lvl2pPr>
              <a:defRPr sz="11035"/>
            </a:lvl2pPr>
            <a:lvl3pPr>
              <a:defRPr sz="9458"/>
            </a:lvl3pPr>
            <a:lvl4pPr>
              <a:defRPr sz="7882"/>
            </a:lvl4pPr>
            <a:lvl5pPr>
              <a:defRPr sz="7882"/>
            </a:lvl5pPr>
            <a:lvl6pPr>
              <a:defRPr sz="7882"/>
            </a:lvl6pPr>
            <a:lvl7pPr>
              <a:defRPr sz="7882"/>
            </a:lvl7pPr>
            <a:lvl8pPr>
              <a:defRPr sz="7882"/>
            </a:lvl8pPr>
            <a:lvl9pPr>
              <a:defRPr sz="788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2186" y="15119985"/>
            <a:ext cx="11622629" cy="28011643"/>
          </a:xfrm>
        </p:spPr>
        <p:txBody>
          <a:bodyPr/>
          <a:lstStyle>
            <a:lvl1pPr marL="0" indent="0">
              <a:buNone/>
              <a:defRPr sz="6306"/>
            </a:lvl1pPr>
            <a:lvl2pPr marL="1801825" indent="0">
              <a:buNone/>
              <a:defRPr sz="5517"/>
            </a:lvl2pPr>
            <a:lvl3pPr marL="3603650" indent="0">
              <a:buNone/>
              <a:defRPr sz="4729"/>
            </a:lvl3pPr>
            <a:lvl4pPr marL="5405476" indent="0">
              <a:buNone/>
              <a:defRPr sz="3941"/>
            </a:lvl4pPr>
            <a:lvl5pPr marL="7207301" indent="0">
              <a:buNone/>
              <a:defRPr sz="3941"/>
            </a:lvl5pPr>
            <a:lvl6pPr marL="9009126" indent="0">
              <a:buNone/>
              <a:defRPr sz="3941"/>
            </a:lvl6pPr>
            <a:lvl7pPr marL="10810951" indent="0">
              <a:buNone/>
              <a:defRPr sz="3941"/>
            </a:lvl7pPr>
            <a:lvl8pPr marL="12612776" indent="0">
              <a:buNone/>
              <a:defRPr sz="3941"/>
            </a:lvl8pPr>
            <a:lvl9pPr marL="14414602" indent="0">
              <a:buNone/>
              <a:defRPr sz="394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048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82186" y="3359997"/>
            <a:ext cx="11622629" cy="11759988"/>
          </a:xfrm>
        </p:spPr>
        <p:txBody>
          <a:bodyPr anchor="b"/>
          <a:lstStyle>
            <a:lvl1pPr>
              <a:defRPr sz="126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20100" y="7256671"/>
            <a:ext cx="18243352" cy="35816631"/>
          </a:xfrm>
        </p:spPr>
        <p:txBody>
          <a:bodyPr anchor="t"/>
          <a:lstStyle>
            <a:lvl1pPr marL="0" indent="0">
              <a:buNone/>
              <a:defRPr sz="12611"/>
            </a:lvl1pPr>
            <a:lvl2pPr marL="1801825" indent="0">
              <a:buNone/>
              <a:defRPr sz="11035"/>
            </a:lvl2pPr>
            <a:lvl3pPr marL="3603650" indent="0">
              <a:buNone/>
              <a:defRPr sz="9458"/>
            </a:lvl3pPr>
            <a:lvl4pPr marL="5405476" indent="0">
              <a:buNone/>
              <a:defRPr sz="7882"/>
            </a:lvl4pPr>
            <a:lvl5pPr marL="7207301" indent="0">
              <a:buNone/>
              <a:defRPr sz="7882"/>
            </a:lvl5pPr>
            <a:lvl6pPr marL="9009126" indent="0">
              <a:buNone/>
              <a:defRPr sz="7882"/>
            </a:lvl6pPr>
            <a:lvl7pPr marL="10810951" indent="0">
              <a:buNone/>
              <a:defRPr sz="7882"/>
            </a:lvl7pPr>
            <a:lvl8pPr marL="12612776" indent="0">
              <a:buNone/>
              <a:defRPr sz="7882"/>
            </a:lvl8pPr>
            <a:lvl9pPr marL="14414602" indent="0">
              <a:buNone/>
              <a:defRPr sz="788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82186" y="15119985"/>
            <a:ext cx="11622629" cy="28011643"/>
          </a:xfrm>
        </p:spPr>
        <p:txBody>
          <a:bodyPr/>
          <a:lstStyle>
            <a:lvl1pPr marL="0" indent="0">
              <a:buNone/>
              <a:defRPr sz="6306"/>
            </a:lvl1pPr>
            <a:lvl2pPr marL="1801825" indent="0">
              <a:buNone/>
              <a:defRPr sz="5517"/>
            </a:lvl2pPr>
            <a:lvl3pPr marL="3603650" indent="0">
              <a:buNone/>
              <a:defRPr sz="4729"/>
            </a:lvl3pPr>
            <a:lvl4pPr marL="5405476" indent="0">
              <a:buNone/>
              <a:defRPr sz="3941"/>
            </a:lvl4pPr>
            <a:lvl5pPr marL="7207301" indent="0">
              <a:buNone/>
              <a:defRPr sz="3941"/>
            </a:lvl5pPr>
            <a:lvl6pPr marL="9009126" indent="0">
              <a:buNone/>
              <a:defRPr sz="3941"/>
            </a:lvl6pPr>
            <a:lvl7pPr marL="10810951" indent="0">
              <a:buNone/>
              <a:defRPr sz="3941"/>
            </a:lvl7pPr>
            <a:lvl8pPr marL="12612776" indent="0">
              <a:buNone/>
              <a:defRPr sz="3941"/>
            </a:lvl8pPr>
            <a:lvl9pPr marL="14414602" indent="0">
              <a:buNone/>
              <a:defRPr sz="394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C3BE3-3337-4FCF-9F4C-D0276771E87E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51F9-7C56-4049-B377-9A4A02544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128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7492" y="2683342"/>
            <a:ext cx="31081266" cy="97416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7492" y="13416653"/>
            <a:ext cx="31081266" cy="31978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7492" y="46713298"/>
            <a:ext cx="8108156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0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37008" y="46713298"/>
            <a:ext cx="12162234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50602" y="46713298"/>
            <a:ext cx="8108156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2666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3603650" rtl="0" eaLnBrk="1" latinLnBrk="0" hangingPunct="1">
        <a:lnSpc>
          <a:spcPct val="90000"/>
        </a:lnSpc>
        <a:spcBef>
          <a:spcPct val="0"/>
        </a:spcBef>
        <a:buNone/>
        <a:defRPr kumimoji="1" sz="173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0913" indent="-900913" algn="l" defTabSz="3603650" rtl="0" eaLnBrk="1" latinLnBrk="0" hangingPunct="1">
        <a:lnSpc>
          <a:spcPct val="90000"/>
        </a:lnSpc>
        <a:spcBef>
          <a:spcPts val="3941"/>
        </a:spcBef>
        <a:buFont typeface="Arial" panose="020B0604020202020204" pitchFamily="34" charset="0"/>
        <a:buChar char="•"/>
        <a:defRPr kumimoji="1" sz="11035" kern="1200">
          <a:solidFill>
            <a:schemeClr val="tx1"/>
          </a:solidFill>
          <a:latin typeface="+mn-lt"/>
          <a:ea typeface="+mn-ea"/>
          <a:cs typeface="+mn-cs"/>
        </a:defRPr>
      </a:lvl1pPr>
      <a:lvl2pPr marL="2702738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9458" kern="1200">
          <a:solidFill>
            <a:schemeClr val="tx1"/>
          </a:solidFill>
          <a:latin typeface="+mn-lt"/>
          <a:ea typeface="+mn-ea"/>
          <a:cs typeface="+mn-cs"/>
        </a:defRPr>
      </a:lvl2pPr>
      <a:lvl3pPr marL="4504563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882" kern="1200">
          <a:solidFill>
            <a:schemeClr val="tx1"/>
          </a:solidFill>
          <a:latin typeface="+mn-lt"/>
          <a:ea typeface="+mn-ea"/>
          <a:cs typeface="+mn-cs"/>
        </a:defRPr>
      </a:lvl3pPr>
      <a:lvl4pPr marL="6306388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4pPr>
      <a:lvl5pPr marL="8108213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5pPr>
      <a:lvl6pPr marL="9910039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6pPr>
      <a:lvl7pPr marL="11711864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7pPr>
      <a:lvl8pPr marL="13513689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8pPr>
      <a:lvl9pPr marL="15315514" indent="-900913" algn="l" defTabSz="3603650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1pPr>
      <a:lvl2pPr marL="1801825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2pPr>
      <a:lvl3pPr marL="3603650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3pPr>
      <a:lvl4pPr marL="5405476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4pPr>
      <a:lvl5pPr marL="7207301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5pPr>
      <a:lvl6pPr marL="9009126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6pPr>
      <a:lvl7pPr marL="10810951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7pPr>
      <a:lvl8pPr marL="12612776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8pPr>
      <a:lvl9pPr marL="14414602" algn="l" defTabSz="3603650" rtl="0" eaLnBrk="1" latinLnBrk="0" hangingPunct="1">
        <a:defRPr kumimoji="1" sz="70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566D64D-DD30-4BD4-97D3-9EA13E5F1E0C}"/>
              </a:ext>
            </a:extLst>
          </p:cNvPr>
          <p:cNvSpPr txBox="1"/>
          <p:nvPr/>
        </p:nvSpPr>
        <p:spPr>
          <a:xfrm>
            <a:off x="2250416" y="877872"/>
            <a:ext cx="87223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0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Video1</a:t>
            </a:r>
            <a:endParaRPr kumimoji="1" lang="ja-JP" altLang="en-US" sz="6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" name="MSTO-211H PDPN 6 timelapse GFP-">
            <a:hlinkClick r:id="" action="ppaction://media"/>
            <a:extLst>
              <a:ext uri="{FF2B5EF4-FFF2-40B4-BE49-F238E27FC236}">
                <a16:creationId xmlns:a16="http://schemas.microsoft.com/office/drawing/2014/main" id="{F885B11F-8D9E-429A-95C6-AD31AE5FF03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191944" y="3689528"/>
            <a:ext cx="10242622" cy="10242624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6EB2DBF6-F97D-AC43-A461-A3A4377984D2}"/>
              </a:ext>
            </a:extLst>
          </p:cNvPr>
          <p:cNvSpPr/>
          <p:nvPr/>
        </p:nvSpPr>
        <p:spPr>
          <a:xfrm>
            <a:off x="2250416" y="14990442"/>
            <a:ext cx="32746166" cy="68634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88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Video 1</a:t>
            </a:r>
            <a:endParaRPr lang="ja-JP" altLang="ja-JP" sz="8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88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ime-lapse imaging of MSTO-211H-PDPN-luc-GFP with microscopic observations before and after NIR-PIT for 30 minutes.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66163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9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80</TotalTime>
  <Words>20</Words>
  <Application>Microsoft Macintosh PowerPoint</Application>
  <PresentationFormat>ユーザー設定</PresentationFormat>
  <Paragraphs>3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侑子 西永</dc:creator>
  <cp:lastModifiedBy>Sato Kazuhide</cp:lastModifiedBy>
  <cp:revision>559</cp:revision>
  <dcterms:created xsi:type="dcterms:W3CDTF">2019-08-08T02:32:34Z</dcterms:created>
  <dcterms:modified xsi:type="dcterms:W3CDTF">2020-04-20T01:32:28Z</dcterms:modified>
</cp:coreProperties>
</file>